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536" r:id="rId2"/>
    <p:sldId id="567" r:id="rId3"/>
    <p:sldId id="586" r:id="rId4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02" userDrawn="1">
          <p15:clr>
            <a:srgbClr val="A4A3A4"/>
          </p15:clr>
        </p15:guide>
        <p15:guide id="2" pos="519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テーマ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383"/>
    <p:restoredTop sz="79732"/>
  </p:normalViewPr>
  <p:slideViewPr>
    <p:cSldViewPr snapToObjects="1">
      <p:cViewPr varScale="1">
        <p:scale>
          <a:sx n="87" d="100"/>
          <a:sy n="87" d="100"/>
        </p:scale>
        <p:origin x="2568" y="184"/>
      </p:cViewPr>
      <p:guideLst>
        <p:guide orient="horz" pos="3702"/>
        <p:guide pos="519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Objects="1">
      <p:cViewPr varScale="1">
        <p:scale>
          <a:sx n="65" d="100"/>
          <a:sy n="65" d="100"/>
        </p:scale>
        <p:origin x="-2632" y="-10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komiwa/Desktop/220829%20ABO&#30452;&#12375;/220829%20&#26085;&#36196;AMR&#32676;raw%20data%20anti%20A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komiwa/Desktop/220829%20ABO&#30452;&#12375;/220829%20&#26085;&#36196;AMR&#32676;raw%20data%20anti%20A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nti A 抗体価 対数 sup3 (2)'!$N$2</c:f>
              <c:strCache>
                <c:ptCount val="1"/>
                <c:pt idx="0">
                  <c:v>IgG 凝集反応（DC)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0DE0-AE45-8C01-3CD038570BA3}"/>
              </c:ext>
            </c:extLst>
          </c:dPt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power"/>
            <c:dispRSqr val="1"/>
            <c:dispEq val="0"/>
            <c:trendlineLbl>
              <c:layout>
                <c:manualLayout>
                  <c:x val="0.14740616797900263"/>
                  <c:y val="0.4446420239136774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4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anti A 抗体価 対数 sup3 (2)'!$M$3:$M$44</c:f>
              <c:numCache>
                <c:formatCode>General</c:formatCode>
                <c:ptCount val="42"/>
                <c:pt idx="0">
                  <c:v>94212</c:v>
                </c:pt>
                <c:pt idx="1">
                  <c:v>72801</c:v>
                </c:pt>
                <c:pt idx="2">
                  <c:v>125136</c:v>
                </c:pt>
                <c:pt idx="3">
                  <c:v>100951</c:v>
                </c:pt>
                <c:pt idx="4">
                  <c:v>27620</c:v>
                </c:pt>
                <c:pt idx="5">
                  <c:v>40431</c:v>
                </c:pt>
                <c:pt idx="6">
                  <c:v>66889</c:v>
                </c:pt>
                <c:pt idx="7">
                  <c:v>132097</c:v>
                </c:pt>
                <c:pt idx="8">
                  <c:v>57996</c:v>
                </c:pt>
                <c:pt idx="9">
                  <c:v>64933</c:v>
                </c:pt>
                <c:pt idx="10">
                  <c:v>230109</c:v>
                </c:pt>
                <c:pt idx="11">
                  <c:v>160159</c:v>
                </c:pt>
                <c:pt idx="12">
                  <c:v>5271</c:v>
                </c:pt>
                <c:pt idx="13">
                  <c:v>1507</c:v>
                </c:pt>
                <c:pt idx="14">
                  <c:v>13671</c:v>
                </c:pt>
                <c:pt idx="15">
                  <c:v>7781</c:v>
                </c:pt>
                <c:pt idx="16">
                  <c:v>176067</c:v>
                </c:pt>
                <c:pt idx="17">
                  <c:v>8612</c:v>
                </c:pt>
                <c:pt idx="18">
                  <c:v>74305</c:v>
                </c:pt>
                <c:pt idx="19">
                  <c:v>136425</c:v>
                </c:pt>
                <c:pt idx="20">
                  <c:v>14568</c:v>
                </c:pt>
                <c:pt idx="21">
                  <c:v>24164</c:v>
                </c:pt>
                <c:pt idx="22">
                  <c:v>18314</c:v>
                </c:pt>
                <c:pt idx="23">
                  <c:v>8589</c:v>
                </c:pt>
                <c:pt idx="24">
                  <c:v>10830</c:v>
                </c:pt>
                <c:pt idx="25">
                  <c:v>123318</c:v>
                </c:pt>
                <c:pt idx="26">
                  <c:v>10090</c:v>
                </c:pt>
                <c:pt idx="27">
                  <c:v>55010</c:v>
                </c:pt>
                <c:pt idx="28">
                  <c:v>109986</c:v>
                </c:pt>
                <c:pt idx="29">
                  <c:v>20824</c:v>
                </c:pt>
                <c:pt idx="30">
                  <c:v>10964</c:v>
                </c:pt>
                <c:pt idx="31" formatCode="0_ ">
                  <c:v>11179</c:v>
                </c:pt>
                <c:pt idx="32">
                  <c:v>69381</c:v>
                </c:pt>
                <c:pt idx="33">
                  <c:v>159384</c:v>
                </c:pt>
                <c:pt idx="34">
                  <c:v>25714</c:v>
                </c:pt>
                <c:pt idx="35" formatCode="0_ ">
                  <c:v>3198</c:v>
                </c:pt>
                <c:pt idx="36" formatCode="0_ ">
                  <c:v>121256</c:v>
                </c:pt>
                <c:pt idx="37" formatCode="0_ ">
                  <c:v>15274</c:v>
                </c:pt>
                <c:pt idx="38">
                  <c:v>5837</c:v>
                </c:pt>
                <c:pt idx="39">
                  <c:v>5679</c:v>
                </c:pt>
                <c:pt idx="40">
                  <c:v>12980</c:v>
                </c:pt>
                <c:pt idx="41" formatCode="0_ ">
                  <c:v>71281</c:v>
                </c:pt>
              </c:numCache>
            </c:numRef>
          </c:xVal>
          <c:yVal>
            <c:numRef>
              <c:f>'anti A 抗体価 対数 sup3 (2)'!$N$3:$N$44</c:f>
              <c:numCache>
                <c:formatCode>General</c:formatCode>
                <c:ptCount val="42"/>
                <c:pt idx="0">
                  <c:v>64</c:v>
                </c:pt>
                <c:pt idx="1">
                  <c:v>256</c:v>
                </c:pt>
                <c:pt idx="2">
                  <c:v>256</c:v>
                </c:pt>
                <c:pt idx="3">
                  <c:v>256</c:v>
                </c:pt>
                <c:pt idx="4">
                  <c:v>64</c:v>
                </c:pt>
                <c:pt idx="5">
                  <c:v>64</c:v>
                </c:pt>
                <c:pt idx="6">
                  <c:v>64</c:v>
                </c:pt>
                <c:pt idx="7">
                  <c:v>128</c:v>
                </c:pt>
                <c:pt idx="8">
                  <c:v>128</c:v>
                </c:pt>
                <c:pt idx="9">
                  <c:v>64</c:v>
                </c:pt>
                <c:pt idx="10">
                  <c:v>512</c:v>
                </c:pt>
                <c:pt idx="11">
                  <c:v>1024</c:v>
                </c:pt>
                <c:pt idx="12">
                  <c:v>1</c:v>
                </c:pt>
                <c:pt idx="13">
                  <c:v>1</c:v>
                </c:pt>
                <c:pt idx="14">
                  <c:v>16</c:v>
                </c:pt>
                <c:pt idx="15">
                  <c:v>16</c:v>
                </c:pt>
                <c:pt idx="16">
                  <c:v>256</c:v>
                </c:pt>
                <c:pt idx="17">
                  <c:v>8</c:v>
                </c:pt>
                <c:pt idx="18">
                  <c:v>128</c:v>
                </c:pt>
                <c:pt idx="19">
                  <c:v>256</c:v>
                </c:pt>
                <c:pt idx="20">
                  <c:v>16</c:v>
                </c:pt>
                <c:pt idx="21">
                  <c:v>32</c:v>
                </c:pt>
                <c:pt idx="22">
                  <c:v>32</c:v>
                </c:pt>
                <c:pt idx="23">
                  <c:v>8</c:v>
                </c:pt>
                <c:pt idx="24">
                  <c:v>32</c:v>
                </c:pt>
                <c:pt idx="25">
                  <c:v>32</c:v>
                </c:pt>
                <c:pt idx="26">
                  <c:v>8</c:v>
                </c:pt>
                <c:pt idx="27">
                  <c:v>64</c:v>
                </c:pt>
                <c:pt idx="28">
                  <c:v>128</c:v>
                </c:pt>
                <c:pt idx="29">
                  <c:v>64</c:v>
                </c:pt>
                <c:pt idx="30">
                  <c:v>4</c:v>
                </c:pt>
                <c:pt idx="31" formatCode="0_ ">
                  <c:v>32</c:v>
                </c:pt>
                <c:pt idx="32">
                  <c:v>64</c:v>
                </c:pt>
                <c:pt idx="33">
                  <c:v>256</c:v>
                </c:pt>
                <c:pt idx="34">
                  <c:v>64</c:v>
                </c:pt>
                <c:pt idx="35" formatCode="0_ ">
                  <c:v>8</c:v>
                </c:pt>
                <c:pt idx="36" formatCode="0_ ">
                  <c:v>16</c:v>
                </c:pt>
                <c:pt idx="37" formatCode="0_ ">
                  <c:v>32</c:v>
                </c:pt>
                <c:pt idx="38">
                  <c:v>1</c:v>
                </c:pt>
                <c:pt idx="39">
                  <c:v>1</c:v>
                </c:pt>
                <c:pt idx="40">
                  <c:v>8</c:v>
                </c:pt>
                <c:pt idx="41" formatCode="0_ ">
                  <c:v>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DE0-AE45-8C01-3CD038570B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2774015"/>
        <c:axId val="602292223"/>
      </c:scatterChart>
      <c:valAx>
        <c:axId val="602774015"/>
        <c:scaling>
          <c:logBase val="10"/>
          <c:orientation val="minMax"/>
          <c:min val="1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1"/>
                  <a:t>MFI</a:t>
                </a:r>
                <a:endParaRPr lang="ja-JP" altLang="en-US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02292223"/>
        <c:crosses val="autoZero"/>
        <c:crossBetween val="midCat"/>
      </c:valAx>
      <c:valAx>
        <c:axId val="602292223"/>
        <c:scaling>
          <c:logBase val="2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1"/>
                  <a:t>Hemagglutinin titer</a:t>
                </a:r>
                <a:endParaRPr lang="ja-JP" altLang="en-US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0277401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nti A 抗体価 対数 sup3 (2)'!$R$2</c:f>
              <c:strCache>
                <c:ptCount val="1"/>
                <c:pt idx="0">
                  <c:v>IgM 凝集反応(NS)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38CD-C14D-95CF-228B3139DAC4}"/>
              </c:ext>
            </c:extLst>
          </c:dPt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power"/>
            <c:dispRSqr val="1"/>
            <c:dispEq val="0"/>
            <c:trendlineLbl>
              <c:layout>
                <c:manualLayout>
                  <c:x val="0.14740616797900263"/>
                  <c:y val="0.4446420239136774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4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anti A 抗体価 対数 sup3 (2)'!$Q$3:$Q$44</c:f>
              <c:numCache>
                <c:formatCode>General</c:formatCode>
                <c:ptCount val="42"/>
                <c:pt idx="0">
                  <c:v>33326</c:v>
                </c:pt>
                <c:pt idx="1">
                  <c:v>17107</c:v>
                </c:pt>
                <c:pt idx="2">
                  <c:v>118524</c:v>
                </c:pt>
                <c:pt idx="3">
                  <c:v>11120</c:v>
                </c:pt>
                <c:pt idx="4">
                  <c:v>40365</c:v>
                </c:pt>
                <c:pt idx="5">
                  <c:v>77583</c:v>
                </c:pt>
                <c:pt idx="6">
                  <c:v>43464</c:v>
                </c:pt>
                <c:pt idx="7">
                  <c:v>92960</c:v>
                </c:pt>
                <c:pt idx="8">
                  <c:v>28854</c:v>
                </c:pt>
                <c:pt idx="9">
                  <c:v>29821</c:v>
                </c:pt>
                <c:pt idx="10">
                  <c:v>91928</c:v>
                </c:pt>
                <c:pt idx="11">
                  <c:v>33665</c:v>
                </c:pt>
                <c:pt idx="12">
                  <c:v>15778</c:v>
                </c:pt>
                <c:pt idx="13">
                  <c:v>2898</c:v>
                </c:pt>
                <c:pt idx="14">
                  <c:v>35834</c:v>
                </c:pt>
                <c:pt idx="15">
                  <c:v>40011</c:v>
                </c:pt>
                <c:pt idx="16">
                  <c:v>46385</c:v>
                </c:pt>
                <c:pt idx="17">
                  <c:v>14733</c:v>
                </c:pt>
                <c:pt idx="18">
                  <c:v>9990</c:v>
                </c:pt>
                <c:pt idx="19">
                  <c:v>16328</c:v>
                </c:pt>
                <c:pt idx="20">
                  <c:v>12557</c:v>
                </c:pt>
                <c:pt idx="21">
                  <c:v>17192</c:v>
                </c:pt>
                <c:pt idx="22">
                  <c:v>8102</c:v>
                </c:pt>
                <c:pt idx="23">
                  <c:v>73981</c:v>
                </c:pt>
                <c:pt idx="24">
                  <c:v>206329</c:v>
                </c:pt>
                <c:pt idx="25">
                  <c:v>16960</c:v>
                </c:pt>
                <c:pt idx="26">
                  <c:v>11510</c:v>
                </c:pt>
                <c:pt idx="27">
                  <c:v>10723</c:v>
                </c:pt>
                <c:pt idx="28">
                  <c:v>31832</c:v>
                </c:pt>
                <c:pt idx="29">
                  <c:v>6741</c:v>
                </c:pt>
                <c:pt idx="30">
                  <c:v>26332</c:v>
                </c:pt>
                <c:pt idx="31" formatCode="0_ ">
                  <c:v>11529</c:v>
                </c:pt>
                <c:pt idx="32">
                  <c:v>7648</c:v>
                </c:pt>
                <c:pt idx="33">
                  <c:v>40254</c:v>
                </c:pt>
                <c:pt idx="34">
                  <c:v>25313</c:v>
                </c:pt>
                <c:pt idx="35" formatCode="0_ ">
                  <c:v>37444</c:v>
                </c:pt>
                <c:pt idx="36" formatCode="0_ ">
                  <c:v>14368</c:v>
                </c:pt>
                <c:pt idx="37" formatCode="0_ ">
                  <c:v>12370</c:v>
                </c:pt>
                <c:pt idx="38">
                  <c:v>37760</c:v>
                </c:pt>
                <c:pt idx="39">
                  <c:v>37046</c:v>
                </c:pt>
                <c:pt idx="40">
                  <c:v>35484</c:v>
                </c:pt>
                <c:pt idx="41" formatCode="0_ ">
                  <c:v>19623</c:v>
                </c:pt>
              </c:numCache>
            </c:numRef>
          </c:xVal>
          <c:yVal>
            <c:numRef>
              <c:f>'anti A 抗体価 対数 sup3 (2)'!$R$3:$R$44</c:f>
              <c:numCache>
                <c:formatCode>General</c:formatCode>
                <c:ptCount val="42"/>
                <c:pt idx="0">
                  <c:v>64</c:v>
                </c:pt>
                <c:pt idx="1">
                  <c:v>16</c:v>
                </c:pt>
                <c:pt idx="2">
                  <c:v>64</c:v>
                </c:pt>
                <c:pt idx="3">
                  <c:v>32</c:v>
                </c:pt>
                <c:pt idx="4">
                  <c:v>32</c:v>
                </c:pt>
                <c:pt idx="5">
                  <c:v>32</c:v>
                </c:pt>
                <c:pt idx="6">
                  <c:v>32</c:v>
                </c:pt>
                <c:pt idx="7">
                  <c:v>128</c:v>
                </c:pt>
                <c:pt idx="8">
                  <c:v>32</c:v>
                </c:pt>
                <c:pt idx="9">
                  <c:v>32</c:v>
                </c:pt>
                <c:pt idx="10">
                  <c:v>64</c:v>
                </c:pt>
                <c:pt idx="11">
                  <c:v>64</c:v>
                </c:pt>
                <c:pt idx="12">
                  <c:v>8</c:v>
                </c:pt>
                <c:pt idx="13">
                  <c:v>8</c:v>
                </c:pt>
                <c:pt idx="14">
                  <c:v>16</c:v>
                </c:pt>
                <c:pt idx="15">
                  <c:v>16</c:v>
                </c:pt>
                <c:pt idx="16">
                  <c:v>16</c:v>
                </c:pt>
                <c:pt idx="17">
                  <c:v>4</c:v>
                </c:pt>
                <c:pt idx="18">
                  <c:v>8</c:v>
                </c:pt>
                <c:pt idx="19">
                  <c:v>16</c:v>
                </c:pt>
                <c:pt idx="20">
                  <c:v>4</c:v>
                </c:pt>
                <c:pt idx="21">
                  <c:v>16</c:v>
                </c:pt>
                <c:pt idx="22">
                  <c:v>16</c:v>
                </c:pt>
                <c:pt idx="23">
                  <c:v>128</c:v>
                </c:pt>
                <c:pt idx="24">
                  <c:v>128</c:v>
                </c:pt>
                <c:pt idx="25">
                  <c:v>32</c:v>
                </c:pt>
                <c:pt idx="26">
                  <c:v>4</c:v>
                </c:pt>
                <c:pt idx="27">
                  <c:v>16</c:v>
                </c:pt>
                <c:pt idx="28">
                  <c:v>32</c:v>
                </c:pt>
                <c:pt idx="29">
                  <c:v>16</c:v>
                </c:pt>
                <c:pt idx="30">
                  <c:v>32</c:v>
                </c:pt>
                <c:pt idx="31" formatCode="0_ ">
                  <c:v>32</c:v>
                </c:pt>
                <c:pt idx="32">
                  <c:v>8</c:v>
                </c:pt>
                <c:pt idx="33">
                  <c:v>64</c:v>
                </c:pt>
                <c:pt idx="34">
                  <c:v>32</c:v>
                </c:pt>
                <c:pt idx="35" formatCode="0_ ">
                  <c:v>64</c:v>
                </c:pt>
                <c:pt idx="36" formatCode="0_ ">
                  <c:v>16</c:v>
                </c:pt>
                <c:pt idx="37" formatCode="0_ ">
                  <c:v>16</c:v>
                </c:pt>
                <c:pt idx="38">
                  <c:v>8</c:v>
                </c:pt>
                <c:pt idx="39">
                  <c:v>16</c:v>
                </c:pt>
                <c:pt idx="40">
                  <c:v>16</c:v>
                </c:pt>
                <c:pt idx="41" formatCode="0_ 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8CD-C14D-95CF-228B3139DA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2774015"/>
        <c:axId val="602292223"/>
      </c:scatterChart>
      <c:valAx>
        <c:axId val="602774015"/>
        <c:scaling>
          <c:logBase val="10"/>
          <c:orientation val="minMax"/>
          <c:min val="1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1"/>
                  <a:t>MFI</a:t>
                </a:r>
                <a:endParaRPr lang="ja-JP" altLang="en-US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02292223"/>
        <c:crosses val="autoZero"/>
        <c:crossBetween val="midCat"/>
      </c:valAx>
      <c:valAx>
        <c:axId val="602292223"/>
        <c:scaling>
          <c:logBase val="2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1"/>
                  <a:t>Hemagglutinin titer</a:t>
                </a:r>
                <a:endParaRPr lang="ja-JP" altLang="en-US" sz="14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0277401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49AC79-E2CB-3843-AC7E-46CF79290497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A38A19-D1C3-2C41-AA67-56ED333B78C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2063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A38A19-D1C3-2C41-AA67-56ED333B78CC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7439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15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518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035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125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954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030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6253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6492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843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712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469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DE66-E748-5746-8D6A-AB02B202D686}" type="datetimeFigureOut">
              <a:rPr kumimoji="1" lang="ja-JP" altLang="en-US" smtClean="0"/>
              <a:pPr/>
              <a:t>2024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11E19-E6D1-BF40-83B5-02D3E8F1A88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143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56216" y="817335"/>
            <a:ext cx="2592000" cy="1800000"/>
          </a:xfrm>
          <a:prstGeom prst="rect">
            <a:avLst/>
          </a:prstGeom>
        </p:spPr>
      </p:pic>
      <p:pic>
        <p:nvPicPr>
          <p:cNvPr id="17" name="図 16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305141" y="817928"/>
            <a:ext cx="2592000" cy="1800000"/>
          </a:xfrm>
          <a:prstGeom prst="rect">
            <a:avLst/>
          </a:prstGeom>
        </p:spPr>
      </p:pic>
      <p:pic>
        <p:nvPicPr>
          <p:cNvPr id="19" name="図 18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350141" y="817335"/>
            <a:ext cx="2592000" cy="1800000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65650" y="3500514"/>
            <a:ext cx="2592000" cy="1800000"/>
          </a:xfrm>
          <a:prstGeom prst="rect">
            <a:avLst/>
          </a:prstGeom>
        </p:spPr>
      </p:pic>
      <p:pic>
        <p:nvPicPr>
          <p:cNvPr id="21" name="図 20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312612" y="3500514"/>
            <a:ext cx="2592000" cy="1800000"/>
          </a:xfrm>
          <a:prstGeom prst="rect">
            <a:avLst/>
          </a:prstGeom>
        </p:spPr>
      </p:pic>
      <p:pic>
        <p:nvPicPr>
          <p:cNvPr id="22" name="図 21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6359575" y="3500514"/>
            <a:ext cx="2592000" cy="1800000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170508" y="5387490"/>
            <a:ext cx="8751114" cy="12926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emental data 1: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Measuring of the DAB stain area of A/B antigens using </a:t>
            </a:r>
          </a:p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he image analysis software </a:t>
            </a:r>
            <a:r>
              <a:rPr lang="en-US" altLang="ja-JP" sz="1800" kern="100" dirty="0" err="1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issuemorph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DP. The anti-A/B antibodies were diluted</a:t>
            </a:r>
          </a:p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(dilution magnification ranged from 25x to 800x) and compared in each sample with</a:t>
            </a:r>
          </a:p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the highest DAB/ROI value.</a:t>
            </a:r>
            <a:endParaRPr lang="ja-JP" altLang="ja-JP" sz="1800" kern="100">
              <a:effectLst/>
              <a:latin typeface="Century" panose="020406040505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38598" y="171004"/>
            <a:ext cx="21956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lphaLcParenR"/>
            </a:pPr>
            <a:r>
              <a:rPr kumimoji="1" lang="en-US" altLang="ja-JP" dirty="0"/>
              <a:t>Dilution</a:t>
            </a:r>
            <a:r>
              <a:rPr lang="en-US" altLang="ja-JP" dirty="0"/>
              <a:t> 1:25</a:t>
            </a:r>
          </a:p>
          <a:p>
            <a:r>
              <a:rPr lang="en-US" altLang="ja-JP" dirty="0"/>
              <a:t>       DAB/ROI =0.2</a:t>
            </a:r>
            <a:r>
              <a:rPr kumimoji="1" lang="en-US" altLang="ja-JP" dirty="0"/>
              <a:t> </a:t>
            </a:r>
            <a:r>
              <a:rPr kumimoji="1" lang="ja-JP" altLang="en-US" dirty="0"/>
              <a:t>　　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676727" y="2767207"/>
            <a:ext cx="202087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) Dilution</a:t>
            </a:r>
            <a:r>
              <a:rPr lang="en-US" altLang="ja-JP" dirty="0"/>
              <a:t> 1:400</a:t>
            </a:r>
          </a:p>
          <a:p>
            <a:r>
              <a:rPr lang="en-US" altLang="ja-JP" dirty="0"/>
              <a:t>     DAB/ROI = 0</a:t>
            </a:r>
            <a:r>
              <a:rPr kumimoji="1" lang="en-US" altLang="ja-JP" dirty="0"/>
              <a:t> </a:t>
            </a:r>
            <a:r>
              <a:rPr kumimoji="1" lang="ja-JP" altLang="en-US" dirty="0"/>
              <a:t>　　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48032" y="2767207"/>
            <a:ext cx="24408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) Dilution</a:t>
            </a:r>
            <a:r>
              <a:rPr lang="en-US" altLang="ja-JP" dirty="0"/>
              <a:t> 1:200</a:t>
            </a:r>
          </a:p>
          <a:p>
            <a:r>
              <a:rPr lang="en-US" altLang="ja-JP" dirty="0"/>
              <a:t>     DAB/ROI =0.0008</a:t>
            </a:r>
            <a:r>
              <a:rPr kumimoji="1" lang="en-US" altLang="ja-JP" dirty="0"/>
              <a:t> </a:t>
            </a:r>
            <a:r>
              <a:rPr kumimoji="1" lang="ja-JP" altLang="en-US" dirty="0"/>
              <a:t>　　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597781" y="158699"/>
            <a:ext cx="23238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) Dilution</a:t>
            </a:r>
            <a:r>
              <a:rPr lang="en-US" altLang="ja-JP" dirty="0"/>
              <a:t> 1:100</a:t>
            </a:r>
          </a:p>
          <a:p>
            <a:r>
              <a:rPr lang="en-US" altLang="ja-JP" dirty="0"/>
              <a:t>     DAB/ROI =0.065</a:t>
            </a:r>
            <a:r>
              <a:rPr kumimoji="1" lang="en-US" altLang="ja-JP" dirty="0"/>
              <a:t> </a:t>
            </a:r>
            <a:r>
              <a:rPr kumimoji="1" lang="ja-JP" altLang="en-US" dirty="0"/>
              <a:t>　　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667293" y="171004"/>
            <a:ext cx="21539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) Dilution</a:t>
            </a:r>
            <a:r>
              <a:rPr lang="en-US" altLang="ja-JP" dirty="0"/>
              <a:t> 1:50 </a:t>
            </a:r>
          </a:p>
          <a:p>
            <a:r>
              <a:rPr lang="en-US" altLang="ja-JP" dirty="0"/>
              <a:t>     DAB/ROI =0.17</a:t>
            </a:r>
            <a:r>
              <a:rPr kumimoji="1" lang="ja-JP" altLang="en-US" dirty="0"/>
              <a:t>　　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589970" y="2767207"/>
            <a:ext cx="19150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) Dilution</a:t>
            </a:r>
            <a:r>
              <a:rPr lang="en-US" altLang="ja-JP" dirty="0"/>
              <a:t> 1:800</a:t>
            </a:r>
          </a:p>
          <a:p>
            <a:r>
              <a:rPr lang="en-US" altLang="ja-JP" dirty="0"/>
              <a:t>    DAB/ROI = 0</a:t>
            </a:r>
            <a:r>
              <a:rPr kumimoji="1" lang="en-US" altLang="ja-JP" dirty="0"/>
              <a:t> </a:t>
            </a:r>
            <a:r>
              <a:rPr kumimoji="1" lang="ja-JP" altLang="en-US" dirty="0"/>
              <a:t>　　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61E32219-900D-8844-A9FC-8EEFABCD3F66}"/>
              </a:ext>
            </a:extLst>
          </p:cNvPr>
          <p:cNvGrpSpPr/>
          <p:nvPr/>
        </p:nvGrpSpPr>
        <p:grpSpPr>
          <a:xfrm>
            <a:off x="256216" y="2242043"/>
            <a:ext cx="476412" cy="221203"/>
            <a:chOff x="6359575" y="2631733"/>
            <a:chExt cx="476412" cy="221203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C8179FA8-B390-894B-AC6E-E61896D6539E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C81F820F-08A4-FA42-B3BD-C9B07205ADC9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C170EFA-421E-0E4D-AA8D-7D9C2B92B992}"/>
              </a:ext>
            </a:extLst>
          </p:cNvPr>
          <p:cNvGrpSpPr/>
          <p:nvPr/>
        </p:nvGrpSpPr>
        <p:grpSpPr>
          <a:xfrm>
            <a:off x="3301216" y="2242043"/>
            <a:ext cx="476412" cy="221203"/>
            <a:chOff x="6359575" y="2631733"/>
            <a:chExt cx="476412" cy="221203"/>
          </a:xfrm>
        </p:grpSpPr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897D1B9C-11D1-A544-90B7-2BC914D61D0F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9A482AD5-B272-8448-BF6B-7BC70DA4D8C0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8BD952B3-2D7D-DC4B-8E17-4A07B504086D}"/>
              </a:ext>
            </a:extLst>
          </p:cNvPr>
          <p:cNvGrpSpPr/>
          <p:nvPr/>
        </p:nvGrpSpPr>
        <p:grpSpPr>
          <a:xfrm>
            <a:off x="6359575" y="2242043"/>
            <a:ext cx="476412" cy="221203"/>
            <a:chOff x="6359575" y="2631733"/>
            <a:chExt cx="476412" cy="221203"/>
          </a:xfrm>
        </p:grpSpPr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3C081790-1A12-CA46-B79D-12B0F882DA38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6263CB3-9F4B-EC43-85B7-8CA7AAFD566E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E0A51F3F-B4ED-2744-8B93-F748E3DF79D1}"/>
              </a:ext>
            </a:extLst>
          </p:cNvPr>
          <p:cNvGrpSpPr/>
          <p:nvPr/>
        </p:nvGrpSpPr>
        <p:grpSpPr>
          <a:xfrm>
            <a:off x="265650" y="4912549"/>
            <a:ext cx="476412" cy="221203"/>
            <a:chOff x="6359575" y="2631733"/>
            <a:chExt cx="476412" cy="221203"/>
          </a:xfrm>
        </p:grpSpPr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7B511E0A-F5B0-B544-A55D-6DA06115DF14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AA5A705-7926-8640-85FA-10D70314311A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048CC374-301C-D643-8D3D-FB9C9A8E6B1E}"/>
              </a:ext>
            </a:extLst>
          </p:cNvPr>
          <p:cNvGrpSpPr/>
          <p:nvPr/>
        </p:nvGrpSpPr>
        <p:grpSpPr>
          <a:xfrm>
            <a:off x="3328389" y="4906790"/>
            <a:ext cx="476412" cy="221203"/>
            <a:chOff x="6359575" y="2631733"/>
            <a:chExt cx="476412" cy="221203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3CA88F7E-7F67-3F45-8CAA-F6E72EB85CFB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FAF2A50A-95F8-ED42-8537-AAAB87A5B96B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5F698968-3838-A14B-BE63-741A2B40E850}"/>
              </a:ext>
            </a:extLst>
          </p:cNvPr>
          <p:cNvGrpSpPr/>
          <p:nvPr/>
        </p:nvGrpSpPr>
        <p:grpSpPr>
          <a:xfrm>
            <a:off x="6369009" y="4901031"/>
            <a:ext cx="476412" cy="221203"/>
            <a:chOff x="6359575" y="2631733"/>
            <a:chExt cx="476412" cy="221203"/>
          </a:xfrm>
        </p:grpSpPr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A34CB74D-E790-084A-862A-1C0DD3B4677A}"/>
                </a:ext>
              </a:extLst>
            </p:cNvPr>
            <p:cNvCxnSpPr>
              <a:cxnSpLocks/>
            </p:cNvCxnSpPr>
            <p:nvPr/>
          </p:nvCxnSpPr>
          <p:spPr>
            <a:xfrm>
              <a:off x="6417761" y="2852936"/>
              <a:ext cx="36004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B5F47149-7B06-1B40-BA0B-53593AB8EBF4}"/>
                </a:ext>
              </a:extLst>
            </p:cNvPr>
            <p:cNvSpPr txBox="1"/>
            <p:nvPr/>
          </p:nvSpPr>
          <p:spPr>
            <a:xfrm>
              <a:off x="6359575" y="2631733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/>
                <a:t>100um</a:t>
              </a:r>
              <a:endParaRPr kumimoji="1" lang="ja-JP" altLang="en-US" sz="800" b="1"/>
            </a:p>
          </p:txBody>
        </p:sp>
      </p:grpSp>
    </p:spTree>
    <p:extLst>
      <p:ext uri="{BB962C8B-B14F-4D97-AF65-F5344CB8AC3E}">
        <p14:creationId xmlns:p14="http://schemas.microsoft.com/office/powerpoint/2010/main" val="241234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5B939EE-3CA2-D840-A49F-94BE6F005521}"/>
              </a:ext>
            </a:extLst>
          </p:cNvPr>
          <p:cNvSpPr txBox="1"/>
          <p:nvPr/>
        </p:nvSpPr>
        <p:spPr>
          <a:xfrm>
            <a:off x="1283007" y="384828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A</a:t>
            </a:r>
            <a:r>
              <a:rPr kumimoji="1" lang="en-US" altLang="ja-JP" b="1" dirty="0"/>
              <a:t>)  IgG</a:t>
            </a:r>
            <a:endParaRPr kumimoji="1" lang="ja-JP" altLang="en-US" b="1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80879B4C-35E1-6F4F-8045-6D0EBB407B8F}"/>
              </a:ext>
            </a:extLst>
          </p:cNvPr>
          <p:cNvSpPr txBox="1"/>
          <p:nvPr/>
        </p:nvSpPr>
        <p:spPr>
          <a:xfrm>
            <a:off x="2928163" y="371594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B</a:t>
            </a:r>
            <a:r>
              <a:rPr kumimoji="1" lang="en-US" altLang="ja-JP" b="1" dirty="0"/>
              <a:t>)  IgM</a:t>
            </a:r>
            <a:endParaRPr kumimoji="1" lang="ja-JP" altLang="en-US" b="1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1848513-6375-1841-A952-F5802F55A028}"/>
              </a:ext>
            </a:extLst>
          </p:cNvPr>
          <p:cNvSpPr txBox="1"/>
          <p:nvPr/>
        </p:nvSpPr>
        <p:spPr>
          <a:xfrm>
            <a:off x="4745576" y="409849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C</a:t>
            </a:r>
            <a:r>
              <a:rPr kumimoji="1" lang="en-US" altLang="ja-JP" b="1" dirty="0"/>
              <a:t>)  IgG1</a:t>
            </a:r>
            <a:endParaRPr kumimoji="1" lang="ja-JP" altLang="en-US" b="1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D68FBA3-6D90-2B48-8750-684613345D18}"/>
              </a:ext>
            </a:extLst>
          </p:cNvPr>
          <p:cNvSpPr txBox="1"/>
          <p:nvPr/>
        </p:nvSpPr>
        <p:spPr>
          <a:xfrm>
            <a:off x="6444208" y="404664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D</a:t>
            </a:r>
            <a:r>
              <a:rPr kumimoji="1" lang="en-US" altLang="ja-JP" b="1" dirty="0"/>
              <a:t>)  IgG2</a:t>
            </a: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A434811-DE13-4845-A364-00CD9B1790D3}"/>
              </a:ext>
            </a:extLst>
          </p:cNvPr>
          <p:cNvSpPr txBox="1"/>
          <p:nvPr/>
        </p:nvSpPr>
        <p:spPr>
          <a:xfrm>
            <a:off x="1332129" y="2747685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E</a:t>
            </a:r>
            <a:r>
              <a:rPr kumimoji="1" lang="en-US" altLang="ja-JP" b="1" dirty="0"/>
              <a:t>)  IgG3</a:t>
            </a: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445E8BB-83A9-5E41-81A6-46D397AB7F96}"/>
              </a:ext>
            </a:extLst>
          </p:cNvPr>
          <p:cNvSpPr txBox="1"/>
          <p:nvPr/>
        </p:nvSpPr>
        <p:spPr>
          <a:xfrm>
            <a:off x="3035303" y="2747685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F</a:t>
            </a:r>
            <a:r>
              <a:rPr kumimoji="1" lang="en-US" altLang="ja-JP" b="1" dirty="0"/>
              <a:t>)  IgG4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480FBD5-534E-F44A-909B-90ADFCF08099}"/>
              </a:ext>
            </a:extLst>
          </p:cNvPr>
          <p:cNvSpPr txBox="1"/>
          <p:nvPr/>
        </p:nvSpPr>
        <p:spPr>
          <a:xfrm>
            <a:off x="329566" y="5346169"/>
            <a:ext cx="857491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emental data 2: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lculation of the MFI cut-off values of anti-A </a:t>
            </a:r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IgG,IgM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IgG subclasses antibody and C1q-binding-ability by ROC analysis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F8D771E-019F-6D41-A896-6140270E2ECD}"/>
              </a:ext>
            </a:extLst>
          </p:cNvPr>
          <p:cNvSpPr txBox="1"/>
          <p:nvPr/>
        </p:nvSpPr>
        <p:spPr>
          <a:xfrm rot="16200000">
            <a:off x="660161" y="1387215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65D52A2-A4A7-E445-9E44-2C910E8797BD}"/>
              </a:ext>
            </a:extLst>
          </p:cNvPr>
          <p:cNvSpPr txBox="1"/>
          <p:nvPr/>
        </p:nvSpPr>
        <p:spPr>
          <a:xfrm>
            <a:off x="1401699" y="2216172"/>
            <a:ext cx="8771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5FBA297-736C-C048-B98B-1CADED58657F}"/>
              </a:ext>
            </a:extLst>
          </p:cNvPr>
          <p:cNvSpPr txBox="1"/>
          <p:nvPr/>
        </p:nvSpPr>
        <p:spPr>
          <a:xfrm rot="16200000">
            <a:off x="2317636" y="1391064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EDA49D4-F503-1E46-BC3E-EE6FE1E58661}"/>
              </a:ext>
            </a:extLst>
          </p:cNvPr>
          <p:cNvSpPr txBox="1"/>
          <p:nvPr/>
        </p:nvSpPr>
        <p:spPr>
          <a:xfrm>
            <a:off x="3048288" y="2247960"/>
            <a:ext cx="8771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503EB5B-7AB5-0349-988D-AD017B6ADA2A}"/>
              </a:ext>
            </a:extLst>
          </p:cNvPr>
          <p:cNvSpPr txBox="1"/>
          <p:nvPr/>
        </p:nvSpPr>
        <p:spPr>
          <a:xfrm rot="16200000">
            <a:off x="4073415" y="1394041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4CAE643-9703-1A46-B568-0CE11C022BEC}"/>
              </a:ext>
            </a:extLst>
          </p:cNvPr>
          <p:cNvSpPr txBox="1"/>
          <p:nvPr/>
        </p:nvSpPr>
        <p:spPr>
          <a:xfrm>
            <a:off x="4861709" y="2215926"/>
            <a:ext cx="8771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07CB2FE-CACA-4F41-95C8-6CEC2364AC56}"/>
              </a:ext>
            </a:extLst>
          </p:cNvPr>
          <p:cNvSpPr txBox="1"/>
          <p:nvPr/>
        </p:nvSpPr>
        <p:spPr>
          <a:xfrm>
            <a:off x="4586011" y="2732329"/>
            <a:ext cx="1407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G</a:t>
            </a:r>
            <a:r>
              <a:rPr kumimoji="1" lang="en-US" altLang="ja-JP" b="1" dirty="0"/>
              <a:t>)  C1q-IgG</a:t>
            </a:r>
            <a:endParaRPr kumimoji="1" lang="ja-JP" altLang="en-US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71B8D50-E16A-5B49-B2FE-C3024A680DE0}"/>
              </a:ext>
            </a:extLst>
          </p:cNvPr>
          <p:cNvSpPr txBox="1"/>
          <p:nvPr/>
        </p:nvSpPr>
        <p:spPr>
          <a:xfrm>
            <a:off x="6200353" y="2743755"/>
            <a:ext cx="2120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H</a:t>
            </a:r>
            <a:r>
              <a:rPr kumimoji="1" lang="en-US" altLang="ja-JP" b="1" dirty="0"/>
              <a:t>)  C1q-IgG+IgM</a:t>
            </a:r>
            <a:endParaRPr kumimoji="1" lang="ja-JP" altLang="en-US" b="1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2A087F9-AA81-344A-AD52-DE0E27072932}"/>
              </a:ext>
            </a:extLst>
          </p:cNvPr>
          <p:cNvSpPr txBox="1"/>
          <p:nvPr/>
        </p:nvSpPr>
        <p:spPr>
          <a:xfrm rot="16200000">
            <a:off x="5828393" y="1405366"/>
            <a:ext cx="764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A8B660D-A88A-B14C-A3F9-F35C0E9A368A}"/>
              </a:ext>
            </a:extLst>
          </p:cNvPr>
          <p:cNvSpPr txBox="1"/>
          <p:nvPr/>
        </p:nvSpPr>
        <p:spPr>
          <a:xfrm>
            <a:off x="6574137" y="2259752"/>
            <a:ext cx="87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B93C68A-9646-904E-A33D-CC91273740F5}"/>
              </a:ext>
            </a:extLst>
          </p:cNvPr>
          <p:cNvSpPr txBox="1"/>
          <p:nvPr/>
        </p:nvSpPr>
        <p:spPr>
          <a:xfrm rot="16200000">
            <a:off x="681662" y="3825965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2C31B44-0573-FF43-8B40-82D942EF5F35}"/>
              </a:ext>
            </a:extLst>
          </p:cNvPr>
          <p:cNvSpPr txBox="1"/>
          <p:nvPr/>
        </p:nvSpPr>
        <p:spPr>
          <a:xfrm rot="16200000">
            <a:off x="2434691" y="3801688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BCA353C-D293-F74F-ACDB-CF0EC9396CA4}"/>
              </a:ext>
            </a:extLst>
          </p:cNvPr>
          <p:cNvSpPr txBox="1"/>
          <p:nvPr/>
        </p:nvSpPr>
        <p:spPr>
          <a:xfrm rot="16200000">
            <a:off x="5991176" y="3822739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E8A1A92-FA5C-CE44-883A-62758064837F}"/>
              </a:ext>
            </a:extLst>
          </p:cNvPr>
          <p:cNvSpPr txBox="1"/>
          <p:nvPr/>
        </p:nvSpPr>
        <p:spPr>
          <a:xfrm rot="16200000">
            <a:off x="4107526" y="3811313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nsitivity</a:t>
            </a:r>
            <a:endParaRPr kumimoji="1" lang="ja-JP" altLang="en-US" sz="110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4716FD7-3742-9447-9EB7-956E3DD30647}"/>
              </a:ext>
            </a:extLst>
          </p:cNvPr>
          <p:cNvSpPr txBox="1"/>
          <p:nvPr/>
        </p:nvSpPr>
        <p:spPr>
          <a:xfrm>
            <a:off x="4861709" y="4677385"/>
            <a:ext cx="87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7E95F54-231D-8E42-989D-411CCB0A1BEB}"/>
              </a:ext>
            </a:extLst>
          </p:cNvPr>
          <p:cNvSpPr txBox="1"/>
          <p:nvPr/>
        </p:nvSpPr>
        <p:spPr>
          <a:xfrm>
            <a:off x="6768468" y="4655323"/>
            <a:ext cx="87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177BC9D-DF2B-8145-B753-39CB62777637}"/>
              </a:ext>
            </a:extLst>
          </p:cNvPr>
          <p:cNvSpPr txBox="1"/>
          <p:nvPr/>
        </p:nvSpPr>
        <p:spPr>
          <a:xfrm>
            <a:off x="3151435" y="4655323"/>
            <a:ext cx="87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2891DE2-A202-A642-B295-7B55E35A29FE}"/>
              </a:ext>
            </a:extLst>
          </p:cNvPr>
          <p:cNvSpPr txBox="1"/>
          <p:nvPr/>
        </p:nvSpPr>
        <p:spPr>
          <a:xfrm>
            <a:off x="1448261" y="4692036"/>
            <a:ext cx="8771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1-Specificity</a:t>
            </a:r>
            <a:endParaRPr kumimoji="1" lang="ja-JP" altLang="en-US" sz="110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6CFFC0D-8EC7-C84A-BAA9-B2C31AC6FC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556" t="9863" r="27893" b="65783"/>
          <a:stretch/>
        </p:blipFill>
        <p:spPr>
          <a:xfrm>
            <a:off x="1136398" y="859086"/>
            <a:ext cx="1474961" cy="138887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19D2222-14BF-4C37-2825-C5C368DEB748}"/>
              </a:ext>
            </a:extLst>
          </p:cNvPr>
          <p:cNvSpPr txBox="1"/>
          <p:nvPr/>
        </p:nvSpPr>
        <p:spPr>
          <a:xfrm>
            <a:off x="1605691" y="1524846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64</a:t>
            </a:r>
            <a:r>
              <a:rPr lang="en-US" altLang="ja-JP" sz="900" b="1" dirty="0"/>
              <a:t> </a:t>
            </a:r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27620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83.3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66.7%</a:t>
            </a:r>
            <a:endParaRPr kumimoji="1" lang="en-US" altLang="ja-JP" sz="900" b="1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82464AA-5248-BA42-8B38-16419821E88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108" t="10015" r="28117" b="65429"/>
          <a:stretch/>
        </p:blipFill>
        <p:spPr>
          <a:xfrm>
            <a:off x="2805589" y="876431"/>
            <a:ext cx="1484056" cy="140352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B1EEB60-11BA-2143-2047-D03E5329A1E1}"/>
              </a:ext>
            </a:extLst>
          </p:cNvPr>
          <p:cNvSpPr txBox="1"/>
          <p:nvPr/>
        </p:nvSpPr>
        <p:spPr>
          <a:xfrm>
            <a:off x="3312470" y="1553523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39</a:t>
            </a:r>
            <a:r>
              <a:rPr lang="en-US" altLang="ja-JP" sz="900" b="1" dirty="0"/>
              <a:t> </a:t>
            </a:r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28854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75.0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59.3%</a:t>
            </a:r>
            <a:endParaRPr kumimoji="1" lang="en-US" altLang="ja-JP" sz="900" b="1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BE27E9EB-FCB2-B14A-933C-9EFE82C0C0A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556" t="9864" r="27446" b="65681"/>
          <a:stretch/>
        </p:blipFill>
        <p:spPr>
          <a:xfrm>
            <a:off x="4618228" y="876431"/>
            <a:ext cx="1461836" cy="137152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B696AEA-6AAB-7B61-2F3E-11BE37689DB5}"/>
              </a:ext>
            </a:extLst>
          </p:cNvPr>
          <p:cNvSpPr txBox="1"/>
          <p:nvPr/>
        </p:nvSpPr>
        <p:spPr>
          <a:xfrm>
            <a:off x="5068249" y="1534974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54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23962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66.7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74.1%</a:t>
            </a:r>
            <a:endParaRPr kumimoji="1" lang="en-US" altLang="ja-JP" sz="900" b="1" dirty="0"/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7C87F213-BF43-C74C-90D1-E8C91A5D58D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779" t="9811" r="27670" b="65733"/>
          <a:stretch/>
        </p:blipFill>
        <p:spPr>
          <a:xfrm>
            <a:off x="6329175" y="880874"/>
            <a:ext cx="1441148" cy="136264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50FF40E-6A47-9E4B-3959-9DC0163617F3}"/>
              </a:ext>
            </a:extLst>
          </p:cNvPr>
          <p:cNvSpPr txBox="1"/>
          <p:nvPr/>
        </p:nvSpPr>
        <p:spPr>
          <a:xfrm>
            <a:off x="6768468" y="1524139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79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13944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83.3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63.0%</a:t>
            </a:r>
            <a:endParaRPr kumimoji="1" lang="en-US" altLang="ja-JP" sz="900" b="1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08653238-A819-4044-8C4A-E0CFC732FB1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4556" t="10041" r="26997" b="65185"/>
          <a:stretch/>
        </p:blipFill>
        <p:spPr>
          <a:xfrm>
            <a:off x="2914002" y="3264081"/>
            <a:ext cx="1517993" cy="1413304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E39BA34-C7A7-CBBE-1EA8-C14DAF1F1617}"/>
              </a:ext>
            </a:extLst>
          </p:cNvPr>
          <p:cNvSpPr txBox="1"/>
          <p:nvPr/>
        </p:nvSpPr>
        <p:spPr>
          <a:xfrm>
            <a:off x="3444076" y="3963189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39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280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100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33.3%</a:t>
            </a:r>
            <a:endParaRPr kumimoji="1" lang="en-US" altLang="ja-JP" sz="900" b="1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BBBD51E4-3FF0-7A43-AA97-D5C867A0F31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556" t="9914" r="27893" b="65429"/>
          <a:stretch/>
        </p:blipFill>
        <p:spPr>
          <a:xfrm>
            <a:off x="4617022" y="3279069"/>
            <a:ext cx="1482173" cy="1412967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C9BCB02-CC70-2CC8-156E-895C572C6302}"/>
              </a:ext>
            </a:extLst>
          </p:cNvPr>
          <p:cNvSpPr txBox="1"/>
          <p:nvPr/>
        </p:nvSpPr>
        <p:spPr>
          <a:xfrm>
            <a:off x="5116912" y="3926667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701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7.47%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83.3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66.7%</a:t>
            </a:r>
            <a:endParaRPr kumimoji="1" lang="en-US" altLang="ja-JP" sz="900" b="1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14478A8D-1361-034E-9DD8-CCA3551569B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4779" t="10873" r="27670" b="62573"/>
          <a:stretch/>
        </p:blipFill>
        <p:spPr>
          <a:xfrm>
            <a:off x="6504458" y="3279069"/>
            <a:ext cx="1526179" cy="1443041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428335F-ADD7-5CD1-36DB-D5E578A146C5}"/>
              </a:ext>
            </a:extLst>
          </p:cNvPr>
          <p:cNvSpPr txBox="1"/>
          <p:nvPr/>
        </p:nvSpPr>
        <p:spPr>
          <a:xfrm>
            <a:off x="7012718" y="3983881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659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26.6%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66.7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66.7%</a:t>
            </a:r>
            <a:endParaRPr kumimoji="1" lang="en-US" altLang="ja-JP" sz="900" b="1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7153E4AE-0FB1-FE4F-B793-1F1C8F20C70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4779" t="9913" r="26998" b="65732"/>
          <a:stretch/>
        </p:blipFill>
        <p:spPr>
          <a:xfrm>
            <a:off x="1168131" y="3264081"/>
            <a:ext cx="1517993" cy="1412901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DA5DC81-4FE3-F42E-275D-1E1CF8F6E833}"/>
              </a:ext>
            </a:extLst>
          </p:cNvPr>
          <p:cNvSpPr txBox="1"/>
          <p:nvPr/>
        </p:nvSpPr>
        <p:spPr>
          <a:xfrm>
            <a:off x="1703204" y="3991804"/>
            <a:ext cx="10118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/>
              <a:t>AUC 0.537</a:t>
            </a:r>
            <a:endParaRPr lang="en-US" altLang="ja-JP" sz="900" b="1" dirty="0"/>
          </a:p>
          <a:p>
            <a:r>
              <a:rPr kumimoji="1" lang="en-US" altLang="ja-JP" sz="900" b="1" dirty="0"/>
              <a:t>Cut-off </a:t>
            </a:r>
            <a:r>
              <a:rPr lang="en-US" altLang="ja-JP" sz="900" b="1" dirty="0"/>
              <a:t> 1615</a:t>
            </a:r>
            <a:endParaRPr kumimoji="1" lang="en-US" altLang="ja-JP" sz="900" b="1" dirty="0"/>
          </a:p>
          <a:p>
            <a:r>
              <a:rPr lang="en-US" altLang="ja-JP" sz="900" b="1" dirty="0"/>
              <a:t>Sensitivity 83.3%</a:t>
            </a:r>
          </a:p>
          <a:p>
            <a:r>
              <a:rPr kumimoji="1" lang="en-US" altLang="ja-JP" sz="900" b="1" dirty="0"/>
              <a:t>Specificity </a:t>
            </a:r>
            <a:r>
              <a:rPr lang="en-US" altLang="ja-JP" sz="900" b="1" dirty="0"/>
              <a:t> 40.7%</a:t>
            </a:r>
            <a:endParaRPr kumimoji="1" lang="en-US" altLang="ja-JP" sz="900" b="1" dirty="0"/>
          </a:p>
        </p:txBody>
      </p:sp>
    </p:spTree>
    <p:extLst>
      <p:ext uri="{BB962C8B-B14F-4D97-AF65-F5344CB8AC3E}">
        <p14:creationId xmlns:p14="http://schemas.microsoft.com/office/powerpoint/2010/main" val="2823598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06D4E11-0C3C-9242-A70A-D223A06D9469}"/>
              </a:ext>
            </a:extLst>
          </p:cNvPr>
          <p:cNvSpPr txBox="1"/>
          <p:nvPr/>
        </p:nvSpPr>
        <p:spPr>
          <a:xfrm>
            <a:off x="480122" y="4365104"/>
            <a:ext cx="8266430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upplemental data 3: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Correlation between hemagglutinin titers and MFI of </a:t>
            </a:r>
          </a:p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nti-A antibody IgG and IgM.</a:t>
            </a:r>
            <a:endParaRPr lang="ja-JP" altLang="ja-JP" sz="1800" kern="100">
              <a:effectLst/>
              <a:latin typeface="Century" panose="020406040505050203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endParaRPr kumimoji="1" lang="ja-JP" altLang="en-US" sz="2400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EA43F2-C9F0-DA4E-95D6-4765F38AACAE}"/>
              </a:ext>
            </a:extLst>
          </p:cNvPr>
          <p:cNvSpPr txBox="1"/>
          <p:nvPr/>
        </p:nvSpPr>
        <p:spPr>
          <a:xfrm>
            <a:off x="4860032" y="669171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B</a:t>
            </a:r>
            <a:r>
              <a:rPr kumimoji="1" lang="en-US" altLang="ja-JP" b="1" dirty="0"/>
              <a:t>)  IgM</a:t>
            </a:r>
            <a:endParaRPr kumimoji="1" lang="ja-JP" altLang="en-US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DE580DA-39BF-554E-8536-8AF778291759}"/>
              </a:ext>
            </a:extLst>
          </p:cNvPr>
          <p:cNvSpPr txBox="1"/>
          <p:nvPr/>
        </p:nvSpPr>
        <p:spPr>
          <a:xfrm>
            <a:off x="290609" y="669171"/>
            <a:ext cx="1109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 </a:t>
            </a:r>
            <a:r>
              <a:rPr lang="en-US" altLang="ja-JP" b="1" dirty="0"/>
              <a:t>(A</a:t>
            </a:r>
            <a:r>
              <a:rPr kumimoji="1" lang="en-US" altLang="ja-JP" b="1" dirty="0"/>
              <a:t>)  IgG</a:t>
            </a:r>
            <a:endParaRPr kumimoji="1" lang="ja-JP" altLang="en-US" b="1" dirty="0"/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225B8F45-F8B9-9EEC-D2BD-B55F49CE74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5964203"/>
              </p:ext>
            </p:extLst>
          </p:nvPr>
        </p:nvGraphicFramePr>
        <p:xfrm>
          <a:off x="28199" y="114710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3E6EBB9-6C80-6D42-8CEB-017E5B68E3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0077451"/>
              </p:ext>
            </p:extLst>
          </p:nvPr>
        </p:nvGraphicFramePr>
        <p:xfrm>
          <a:off x="4613337" y="114710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4284985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43</TotalTime>
  <Words>317</Words>
  <Application>Microsoft Macintosh PowerPoint</Application>
  <PresentationFormat>画面に合わせる (4:3)</PresentationFormat>
  <Paragraphs>89</Paragraphs>
  <Slides>3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entury</vt:lpstr>
      <vt:lpstr>ホワイト</vt:lpstr>
      <vt:lpstr>PowerPoint プレゼンテーション</vt:lpstr>
      <vt:lpstr>PowerPoint プレゼンテーション</vt:lpstr>
      <vt:lpstr>PowerPoint プレゼンテーション</vt:lpstr>
    </vt:vector>
  </TitlesOfParts>
  <Company>名古屋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輪 祐子</dc:creator>
  <cp:lastModifiedBy>yuko miwa</cp:lastModifiedBy>
  <cp:revision>1028</cp:revision>
  <cp:lastPrinted>2021-04-01T01:28:22Z</cp:lastPrinted>
  <dcterms:created xsi:type="dcterms:W3CDTF">2013-07-02T09:57:15Z</dcterms:created>
  <dcterms:modified xsi:type="dcterms:W3CDTF">2024-10-08T09:16:04Z</dcterms:modified>
</cp:coreProperties>
</file>